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94"/>
  </p:normalViewPr>
  <p:slideViewPr>
    <p:cSldViewPr snapToGrid="0" snapToObjects="1">
      <p:cViewPr varScale="1">
        <p:scale>
          <a:sx n="108" d="100"/>
          <a:sy n="108" d="100"/>
        </p:scale>
        <p:origin x="5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09A304-84C7-C649-A033-4747BA3C7D70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04B4F7-A857-CB41-9D05-3333E6EF11D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92933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70833D-E762-464F-9D30-2EA59591CC65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702976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9AB57CD-757B-344A-9DBB-3BFEC10A58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30232558-99F3-B146-A061-131D562CB0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3B5A746-7135-E44F-99CE-4CC327A6B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3595E-A64D-6444-BBA8-20BF0113123C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D11C891-42D6-AA41-8B8D-01F57C44D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4F43841-7A08-0940-93C2-A0F31147E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761C6-55FE-7C42-B702-5E84D22E340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5214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4F7D537-7C58-4C46-A54D-E9C9BCE4BD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EB0A86F-8F02-BB4A-B5E8-B24D9120CE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03D2074-12B8-D94D-8330-25A64B8B06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3595E-A64D-6444-BBA8-20BF0113123C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9472FF6-B5A8-C246-9210-BBBB679896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05D2025-D9AF-0541-9D28-6C77978FB3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761C6-55FE-7C42-B702-5E84D22E340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8010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85CE9225-7B7C-004E-97D9-35D601D1E8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F5D8FA6-EF6F-D245-9235-31742875FF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B2648FA-C36C-1B49-A963-DAFBD5968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3595E-A64D-6444-BBA8-20BF0113123C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642D47D-0621-6140-ADEC-55EDE2A72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7482AA3-4617-6C4C-BB40-6A98AAEA62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761C6-55FE-7C42-B702-5E84D22E340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0047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B06892B-810F-044C-A4BF-7FFC9A238F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C298217-E5B3-0A42-B5DC-0BD7FE828C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3061EBD-6C5D-434C-8140-FF74C6F41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3595E-A64D-6444-BBA8-20BF0113123C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EEAB389-D7F4-4947-92C1-766577429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2192C07-708C-E243-8DC9-3E2F17DF98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761C6-55FE-7C42-B702-5E84D22E340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179664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0912824-7B9E-D24B-A25C-0FC90EA8A5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C7DB0D6-E8D5-8E4A-95D4-373E803A10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70BBF5A-985A-5A46-9CE2-472293A72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3595E-A64D-6444-BBA8-20BF0113123C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89A9B7F-5582-8E44-990E-24504478D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A9CAEC8-41CD-4748-879D-8F560743B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761C6-55FE-7C42-B702-5E84D22E340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94939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F05377B-2B71-A942-8F34-2C58FB4B00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B984E1A-3DC1-814A-B487-ED06AC3292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0E70A9E-E5C4-7340-A27B-A4C66C14F1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4362D7C-8A9A-D047-808E-AE30ABDD26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3595E-A64D-6444-BBA8-20BF0113123C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1F30AB6-3625-0145-8157-0997660049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6390B9C-2750-3441-9BB0-EF8BC56686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761C6-55FE-7C42-B702-5E84D22E340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074743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B195D04-D9AF-734C-9FE4-573BD95F01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A984FAC-37F6-F74B-AEAF-47D782D204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B11C18C-1A9F-8E42-9EA3-70A44E8480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585FFDA8-148D-644B-ADD8-1A266FC605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27B2400B-2090-184B-A2C8-82E2478E0C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4E0EB73-60B0-8847-A700-19B624DDE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3595E-A64D-6444-BBA8-20BF0113123C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D994BB07-E871-574D-95DF-965F5209E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C1EFD859-060D-E149-AFD8-31749F0DDB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761C6-55FE-7C42-B702-5E84D22E340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09178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39F6018-14FA-C14D-9E8F-C858C0948A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68C954F-DAAC-BB47-B406-817A28D1D4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3595E-A64D-6444-BBA8-20BF0113123C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078DBBEB-3A88-E64D-A518-55BD675F7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41597638-92B9-4242-A125-5B5830D109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761C6-55FE-7C42-B702-5E84D22E340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2538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1992FCF7-7DA8-FA43-8600-8B127B3C5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3595E-A64D-6444-BBA8-20BF0113123C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497F9D1F-DF6B-8E44-8986-5232FB35FA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B95A922-9230-F545-A527-1B6E5B54F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761C6-55FE-7C42-B702-5E84D22E340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07431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2C2D534-F791-CC4E-9D42-E5DAF55213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6EA283E-B6E0-F243-9BB8-66962DEC75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D295A38-129B-A348-A483-A857D58420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0EFD2FD-139F-D74C-B510-322F537AFB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3595E-A64D-6444-BBA8-20BF0113123C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E8B8BE0-7AF3-3646-A1FD-526164766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48FE2EE-8BB8-6844-8DB7-8AF04CC98E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761C6-55FE-7C42-B702-5E84D22E340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7638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DABFEB0-0B11-1848-BCCF-5A7717B306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AD82BC76-ABCA-5D40-B681-AEBEECF99B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4AFC0BE-B756-CB48-81BE-D55850F9CD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76B5D60-C41D-7444-A84B-05015E5620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3595E-A64D-6444-BBA8-20BF0113123C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E9E1B58-2197-A241-8259-57BC42ADCE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CF72031-9E8B-204E-8624-0A025F291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761C6-55FE-7C42-B702-5E84D22E340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53785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D043DC8E-668D-974C-9643-8DF5CA37AF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5676AC2-8DCD-8643-8A7E-9506739F3A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690B81A-E881-FA4B-B1C4-EAD1CED73E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3595E-A64D-6444-BBA8-20BF0113123C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FC95260-3068-EE4C-9CD5-6ECF024304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C1C8EF3-ECBE-DE46-B363-D92A012892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761C6-55FE-7C42-B702-5E84D22E340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668950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Immagine che contiene screenshot, bianco, cavalcando&#10;&#10;Descrizione generata automaticamente">
            <a:extLst>
              <a:ext uri="{FF2B5EF4-FFF2-40B4-BE49-F238E27FC236}">
                <a16:creationId xmlns:a16="http://schemas.microsoft.com/office/drawing/2014/main" id="{FEC0DBAC-DEAE-1742-9318-B6653A4DAB6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6251"/>
          <a:stretch/>
        </p:blipFill>
        <p:spPr>
          <a:xfrm>
            <a:off x="0" y="302403"/>
            <a:ext cx="12192000" cy="1291565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30594441-1B4C-A642-91CC-2AFA33F6D54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6158"/>
          <a:stretch/>
        </p:blipFill>
        <p:spPr>
          <a:xfrm>
            <a:off x="0" y="1763762"/>
            <a:ext cx="12192000" cy="1225666"/>
          </a:xfrm>
          <a:prstGeom prst="rect">
            <a:avLst/>
          </a:prstGeom>
        </p:spPr>
      </p:pic>
      <p:sp>
        <p:nvSpPr>
          <p:cNvPr id="8" name="Rettangolo 7">
            <a:extLst>
              <a:ext uri="{FF2B5EF4-FFF2-40B4-BE49-F238E27FC236}">
                <a16:creationId xmlns:a16="http://schemas.microsoft.com/office/drawing/2014/main" id="{F4B92D06-E3A5-0544-85FD-3C8D61EACE77}"/>
              </a:ext>
            </a:extLst>
          </p:cNvPr>
          <p:cNvSpPr/>
          <p:nvPr/>
        </p:nvSpPr>
        <p:spPr>
          <a:xfrm>
            <a:off x="9705402" y="235830"/>
            <a:ext cx="300039" cy="2843702"/>
          </a:xfrm>
          <a:prstGeom prst="rect">
            <a:avLst/>
          </a:prstGeom>
          <a:noFill/>
          <a:ln w="3492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C598A168-E24A-194A-B685-466E5CFCD82D}"/>
              </a:ext>
            </a:extLst>
          </p:cNvPr>
          <p:cNvSpPr txBox="1"/>
          <p:nvPr/>
        </p:nvSpPr>
        <p:spPr>
          <a:xfrm>
            <a:off x="-34539" y="-27162"/>
            <a:ext cx="2224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Campania </a:t>
            </a:r>
            <a:r>
              <a:rPr lang="it-IT" sz="1600" dirty="0" err="1"/>
              <a:t>chr</a:t>
            </a:r>
            <a:r>
              <a:rPr lang="it-IT" sz="1600" dirty="0"/>
              <a:t> 9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BFBDEEC4-2C41-3D46-9AFC-8EB93FF798F9}"/>
              </a:ext>
            </a:extLst>
          </p:cNvPr>
          <p:cNvSpPr txBox="1"/>
          <p:nvPr/>
        </p:nvSpPr>
        <p:spPr>
          <a:xfrm>
            <a:off x="-34539" y="1477570"/>
            <a:ext cx="2224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Calabria </a:t>
            </a:r>
            <a:r>
              <a:rPr lang="it-IT" sz="1600" dirty="0" err="1"/>
              <a:t>chr</a:t>
            </a:r>
            <a:r>
              <a:rPr lang="it-IT" sz="1600" dirty="0"/>
              <a:t> 9</a:t>
            </a:r>
          </a:p>
        </p:txBody>
      </p:sp>
      <p:pic>
        <p:nvPicPr>
          <p:cNvPr id="27" name="Immagine 26" descr="Immagine che contiene sedendo, bianco, cavalcando&#10;&#10;Descrizione generata automaticamente">
            <a:extLst>
              <a:ext uri="{FF2B5EF4-FFF2-40B4-BE49-F238E27FC236}">
                <a16:creationId xmlns:a16="http://schemas.microsoft.com/office/drawing/2014/main" id="{B6A44CC9-E445-3847-83FE-1D2E4860670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7253"/>
          <a:stretch/>
        </p:blipFill>
        <p:spPr>
          <a:xfrm>
            <a:off x="0" y="5181239"/>
            <a:ext cx="12192000" cy="1253031"/>
          </a:xfrm>
          <a:prstGeom prst="rect">
            <a:avLst/>
          </a:prstGeom>
        </p:spPr>
      </p:pic>
      <p:pic>
        <p:nvPicPr>
          <p:cNvPr id="28" name="Immagine 27">
            <a:extLst>
              <a:ext uri="{FF2B5EF4-FFF2-40B4-BE49-F238E27FC236}">
                <a16:creationId xmlns:a16="http://schemas.microsoft.com/office/drawing/2014/main" id="{F6F57C00-527A-5B4F-8270-D6AD9C56BCF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4542"/>
          <a:stretch/>
        </p:blipFill>
        <p:spPr>
          <a:xfrm>
            <a:off x="0" y="3458677"/>
            <a:ext cx="12192000" cy="1242935"/>
          </a:xfrm>
          <a:prstGeom prst="rect">
            <a:avLst/>
          </a:prstGeom>
        </p:spPr>
      </p:pic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65206B8D-3705-4C47-A7A4-E3195B09AFCB}"/>
              </a:ext>
            </a:extLst>
          </p:cNvPr>
          <p:cNvSpPr txBox="1"/>
          <p:nvPr/>
        </p:nvSpPr>
        <p:spPr>
          <a:xfrm>
            <a:off x="-34539" y="3058677"/>
            <a:ext cx="2224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Campania </a:t>
            </a:r>
            <a:r>
              <a:rPr lang="it-IT" sz="1600" dirty="0" err="1"/>
              <a:t>chr</a:t>
            </a:r>
            <a:r>
              <a:rPr lang="it-IT" sz="1600" dirty="0"/>
              <a:t> 7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51A8E919-099E-8149-81F7-4B9EFF64ECBD}"/>
              </a:ext>
            </a:extLst>
          </p:cNvPr>
          <p:cNvSpPr txBox="1"/>
          <p:nvPr/>
        </p:nvSpPr>
        <p:spPr>
          <a:xfrm>
            <a:off x="-34539" y="4807971"/>
            <a:ext cx="2224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Calabria </a:t>
            </a:r>
            <a:r>
              <a:rPr lang="it-IT" sz="1600" dirty="0" err="1"/>
              <a:t>chr</a:t>
            </a:r>
            <a:r>
              <a:rPr lang="it-IT" sz="1600" dirty="0"/>
              <a:t> 7</a:t>
            </a:r>
          </a:p>
        </p:txBody>
      </p:sp>
      <p:sp>
        <p:nvSpPr>
          <p:cNvPr id="31" name="Rettangolo 30">
            <a:extLst>
              <a:ext uri="{FF2B5EF4-FFF2-40B4-BE49-F238E27FC236}">
                <a16:creationId xmlns:a16="http://schemas.microsoft.com/office/drawing/2014/main" id="{847A101C-3D1E-8E4D-9ED2-60BC60CE539C}"/>
              </a:ext>
            </a:extLst>
          </p:cNvPr>
          <p:cNvSpPr/>
          <p:nvPr/>
        </p:nvSpPr>
        <p:spPr>
          <a:xfrm>
            <a:off x="1273683" y="3512511"/>
            <a:ext cx="257176" cy="2921759"/>
          </a:xfrm>
          <a:prstGeom prst="rect">
            <a:avLst/>
          </a:prstGeom>
          <a:noFill/>
          <a:ln w="3492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AE389227-D4F5-4888-B528-6751939A8D8B}"/>
              </a:ext>
            </a:extLst>
          </p:cNvPr>
          <p:cNvSpPr txBox="1"/>
          <p:nvPr/>
        </p:nvSpPr>
        <p:spPr>
          <a:xfrm>
            <a:off x="-42986" y="6398966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cs typeface="Times New Roman" panose="02020603050405020304" pitchFamily="18" charset="0"/>
              </a:rPr>
              <a:t>Figure S6: </a:t>
            </a:r>
            <a:r>
              <a:rPr lang="en-US" sz="1200" dirty="0">
                <a:cs typeface="Times New Roman" panose="02020603050405020304" pitchFamily="18" charset="0"/>
              </a:rPr>
              <a:t>Physical localization of private SNPs identified on chromosomes 9 and 7 in genomes from Campania and Calabria. The strongest differences are marked with a blue box. The number of private variants per 1 Mb windows is reported on the y-axis.</a:t>
            </a:r>
          </a:p>
        </p:txBody>
      </p:sp>
    </p:spTree>
    <p:extLst>
      <p:ext uri="{BB962C8B-B14F-4D97-AF65-F5344CB8AC3E}">
        <p14:creationId xmlns:p14="http://schemas.microsoft.com/office/powerpoint/2010/main" val="57670557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59</Words>
  <Application>Microsoft Office PowerPoint</Application>
  <PresentationFormat>Widescreen</PresentationFormat>
  <Paragraphs>6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lvatore esposito</dc:creator>
  <cp:lastModifiedBy>pasquale tripodi</cp:lastModifiedBy>
  <cp:revision>11</cp:revision>
  <dcterms:created xsi:type="dcterms:W3CDTF">2021-02-03T14:17:11Z</dcterms:created>
  <dcterms:modified xsi:type="dcterms:W3CDTF">2021-12-26T14:44:01Z</dcterms:modified>
</cp:coreProperties>
</file>